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69" r:id="rId4"/>
    <p:sldId id="270" r:id="rId5"/>
    <p:sldId id="271" r:id="rId6"/>
    <p:sldId id="272" r:id="rId7"/>
    <p:sldId id="273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420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0837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674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930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885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8223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244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4409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44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3307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894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60F4F-850B-470E-9DC1-22B5BE571801}" type="datetimeFigureOut">
              <a:rPr lang="en-US" smtClean="0"/>
              <a:t>12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887003-AA14-473A-A57B-0C7849246AE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38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23740" t="25531" r="39187" b="56242"/>
          <a:stretch/>
        </p:blipFill>
        <p:spPr>
          <a:xfrm flipH="1">
            <a:off x="2620534" y="1338146"/>
            <a:ext cx="2787805" cy="89258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620535" y="999593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4" name="Isosceles Triangle 3"/>
          <p:cNvSpPr/>
          <p:nvPr/>
        </p:nvSpPr>
        <p:spPr>
          <a:xfrm>
            <a:off x="5074046" y="1010744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494261" y="964130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019673" y="672190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620534" y="728844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21100" y="369099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0906-0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620534" y="411027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387" y="5907287"/>
            <a:ext cx="3718633" cy="271296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0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0" y="57763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5865356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CCB0DE8-25A0-4725-97CA-EDBED90F004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423" t="13046" r="64228" b="77269"/>
          <a:stretch/>
        </p:blipFill>
        <p:spPr>
          <a:xfrm>
            <a:off x="2681216" y="3359446"/>
            <a:ext cx="2843539" cy="92683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1620532C-61E3-49BD-A597-D96DF8551015}"/>
              </a:ext>
            </a:extLst>
          </p:cNvPr>
          <p:cNvSpPr txBox="1"/>
          <p:nvPr/>
        </p:nvSpPr>
        <p:spPr>
          <a:xfrm>
            <a:off x="2749069" y="3045204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6" name="Isosceles Triangle 15">
            <a:extLst>
              <a:ext uri="{FF2B5EF4-FFF2-40B4-BE49-F238E27FC236}">
                <a16:creationId xmlns:a16="http://schemas.microsoft.com/office/drawing/2014/main" id="{E8AC1F1A-B6E7-4FE6-9BAA-081E23FF0948}"/>
              </a:ext>
            </a:extLst>
          </p:cNvPr>
          <p:cNvSpPr/>
          <p:nvPr/>
        </p:nvSpPr>
        <p:spPr>
          <a:xfrm>
            <a:off x="5202580" y="3056355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9DDCEDC-8C20-445D-A10D-2C8FD5491D5D}"/>
              </a:ext>
            </a:extLst>
          </p:cNvPr>
          <p:cNvSpPr txBox="1"/>
          <p:nvPr/>
        </p:nvSpPr>
        <p:spPr>
          <a:xfrm>
            <a:off x="1622795" y="3009741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0073011-DD3D-4BBD-9BEE-540639049690}"/>
              </a:ext>
            </a:extLst>
          </p:cNvPr>
          <p:cNvSpPr txBox="1"/>
          <p:nvPr/>
        </p:nvSpPr>
        <p:spPr>
          <a:xfrm>
            <a:off x="2148207" y="2717801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AC7213C-CBF4-484C-AB0B-48F5D1D4D2FF}"/>
              </a:ext>
            </a:extLst>
          </p:cNvPr>
          <p:cNvSpPr txBox="1"/>
          <p:nvPr/>
        </p:nvSpPr>
        <p:spPr>
          <a:xfrm>
            <a:off x="2749068" y="2774455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AEAF8EF-C33E-4307-9D33-3068C01467DF}"/>
              </a:ext>
            </a:extLst>
          </p:cNvPr>
          <p:cNvSpPr txBox="1"/>
          <p:nvPr/>
        </p:nvSpPr>
        <p:spPr>
          <a:xfrm>
            <a:off x="849634" y="2414710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029283-0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AC3F28F-4CAF-4188-B4B0-6343466337DC}"/>
              </a:ext>
            </a:extLst>
          </p:cNvPr>
          <p:cNvSpPr txBox="1"/>
          <p:nvPr/>
        </p:nvSpPr>
        <p:spPr>
          <a:xfrm>
            <a:off x="2749068" y="2456638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63414CD-6AD3-4D6C-9595-BCB18C64EE9E}"/>
              </a:ext>
            </a:extLst>
          </p:cNvPr>
          <p:cNvSpPr txBox="1"/>
          <p:nvPr/>
        </p:nvSpPr>
        <p:spPr>
          <a:xfrm>
            <a:off x="0" y="221909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0AB5CA83-BE67-46CF-8E44-F0DC8695C1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08757" y="6110483"/>
            <a:ext cx="3290993" cy="2442502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381C3FA9-D521-4A15-9A41-F0560476AA96}"/>
              </a:ext>
            </a:extLst>
          </p:cNvPr>
          <p:cNvSpPr txBox="1"/>
          <p:nvPr/>
        </p:nvSpPr>
        <p:spPr>
          <a:xfrm>
            <a:off x="3523787" y="59101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9908684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715" y="6300054"/>
            <a:ext cx="3126580" cy="2324391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16226" t="60022" r="64834" b="30293"/>
          <a:stretch/>
        </p:blipFill>
        <p:spPr>
          <a:xfrm>
            <a:off x="2658915" y="1310765"/>
            <a:ext cx="2783406" cy="926836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675198" y="1038735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4" name="Isosceles Triangle 13"/>
          <p:cNvSpPr/>
          <p:nvPr/>
        </p:nvSpPr>
        <p:spPr>
          <a:xfrm>
            <a:off x="5128709" y="1049886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1548924" y="1003272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074336" y="71133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675197" y="767986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775763" y="408241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063279-0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675197" y="450169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33814" y="100361"/>
            <a:ext cx="394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78780" y="6211233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CBBD765B-1454-45E7-8FFD-B6D6B0962A7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911" t="12048" r="64227" b="77965"/>
          <a:stretch/>
        </p:blipFill>
        <p:spPr>
          <a:xfrm>
            <a:off x="2704709" y="3299487"/>
            <a:ext cx="2848598" cy="982274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D1C97769-BAD7-4F17-9770-F46013B6309D}"/>
              </a:ext>
            </a:extLst>
          </p:cNvPr>
          <p:cNvSpPr txBox="1"/>
          <p:nvPr/>
        </p:nvSpPr>
        <p:spPr>
          <a:xfrm>
            <a:off x="2771373" y="3011750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18575880-A404-405D-A52E-50FB99983272}"/>
              </a:ext>
            </a:extLst>
          </p:cNvPr>
          <p:cNvSpPr/>
          <p:nvPr/>
        </p:nvSpPr>
        <p:spPr>
          <a:xfrm>
            <a:off x="5224884" y="3022901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808A8F7-C3AE-483A-A50E-B984D7A892E3}"/>
              </a:ext>
            </a:extLst>
          </p:cNvPr>
          <p:cNvSpPr txBox="1"/>
          <p:nvPr/>
        </p:nvSpPr>
        <p:spPr>
          <a:xfrm>
            <a:off x="1645099" y="2976287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F0B1904-BF1F-4273-9A01-EEF4C268B204}"/>
              </a:ext>
            </a:extLst>
          </p:cNvPr>
          <p:cNvSpPr txBox="1"/>
          <p:nvPr/>
        </p:nvSpPr>
        <p:spPr>
          <a:xfrm>
            <a:off x="2170511" y="2684347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C74C047-A016-4E1A-B990-595D9BBEA7EF}"/>
              </a:ext>
            </a:extLst>
          </p:cNvPr>
          <p:cNvSpPr txBox="1"/>
          <p:nvPr/>
        </p:nvSpPr>
        <p:spPr>
          <a:xfrm>
            <a:off x="2771372" y="2741001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875B551-DE13-40F4-A825-699DC6B9E0F1}"/>
              </a:ext>
            </a:extLst>
          </p:cNvPr>
          <p:cNvSpPr txBox="1"/>
          <p:nvPr/>
        </p:nvSpPr>
        <p:spPr>
          <a:xfrm>
            <a:off x="871938" y="2381256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83602-0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C21FF03-2638-4A60-B06A-326FAE4116E3}"/>
              </a:ext>
            </a:extLst>
          </p:cNvPr>
          <p:cNvSpPr txBox="1"/>
          <p:nvPr/>
        </p:nvSpPr>
        <p:spPr>
          <a:xfrm>
            <a:off x="2771372" y="2423184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6F4A912-CD82-4310-83BA-81FEA802FB7B}"/>
              </a:ext>
            </a:extLst>
          </p:cNvPr>
          <p:cNvSpPr txBox="1"/>
          <p:nvPr/>
        </p:nvSpPr>
        <p:spPr>
          <a:xfrm>
            <a:off x="234175" y="2163337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8B2E1381-9AD7-4D1C-8BB2-5604448C7A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32506" y="6280727"/>
            <a:ext cx="3251139" cy="240990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C0C34450-1052-434A-9481-83E760F3F0A3}"/>
              </a:ext>
            </a:extLst>
          </p:cNvPr>
          <p:cNvSpPr txBox="1"/>
          <p:nvPr/>
        </p:nvSpPr>
        <p:spPr>
          <a:xfrm>
            <a:off x="3300761" y="618892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408338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8455" t="59238" r="63171" b="32023"/>
          <a:stretch/>
        </p:blipFill>
        <p:spPr>
          <a:xfrm flipH="1">
            <a:off x="2531915" y="1426154"/>
            <a:ext cx="2776070" cy="85984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4769" y="5748492"/>
            <a:ext cx="3247075" cy="2418034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2559500" y="1059368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4" name="Isosceles Triangle 13"/>
          <p:cNvSpPr/>
          <p:nvPr/>
        </p:nvSpPr>
        <p:spPr>
          <a:xfrm>
            <a:off x="5013011" y="1070519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/>
          <p:cNvSpPr txBox="1"/>
          <p:nvPr/>
        </p:nvSpPr>
        <p:spPr>
          <a:xfrm>
            <a:off x="1433226" y="1023905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58638" y="731965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59499" y="788619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60065" y="428874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295201-0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559499" y="470802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56117" y="133816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56839" y="53414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1C50AC7E-2E2B-40B3-A70C-5FA6DDF749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000" t="13530" r="65694" b="77512"/>
          <a:stretch/>
        </p:blipFill>
        <p:spPr>
          <a:xfrm flipH="1">
            <a:off x="2433195" y="3665474"/>
            <a:ext cx="2907138" cy="87841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30E1F69-31AF-48DE-98A7-26232708A9D7}"/>
              </a:ext>
            </a:extLst>
          </p:cNvPr>
          <p:cNvSpPr txBox="1"/>
          <p:nvPr/>
        </p:nvSpPr>
        <p:spPr>
          <a:xfrm>
            <a:off x="2581803" y="3257077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12D32BA9-AFD1-4164-A95B-14BB55650460}"/>
              </a:ext>
            </a:extLst>
          </p:cNvPr>
          <p:cNvSpPr/>
          <p:nvPr/>
        </p:nvSpPr>
        <p:spPr>
          <a:xfrm>
            <a:off x="5035314" y="3268228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ABDC432-203E-4DEA-89AD-BB9317186CE8}"/>
              </a:ext>
            </a:extLst>
          </p:cNvPr>
          <p:cNvSpPr txBox="1"/>
          <p:nvPr/>
        </p:nvSpPr>
        <p:spPr>
          <a:xfrm>
            <a:off x="1455529" y="3221614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7721311-85D9-4C36-903A-6AF644DCCEA6}"/>
              </a:ext>
            </a:extLst>
          </p:cNvPr>
          <p:cNvSpPr txBox="1"/>
          <p:nvPr/>
        </p:nvSpPr>
        <p:spPr>
          <a:xfrm>
            <a:off x="1980941" y="2929674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158AE2C-29EE-4CA0-BD03-E3F7EDDFE8FF}"/>
              </a:ext>
            </a:extLst>
          </p:cNvPr>
          <p:cNvSpPr txBox="1"/>
          <p:nvPr/>
        </p:nvSpPr>
        <p:spPr>
          <a:xfrm>
            <a:off x="2581802" y="2986328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50BEBCF-1C05-401F-AEC6-BEDB5308B55B}"/>
              </a:ext>
            </a:extLst>
          </p:cNvPr>
          <p:cNvSpPr txBox="1"/>
          <p:nvPr/>
        </p:nvSpPr>
        <p:spPr>
          <a:xfrm>
            <a:off x="682368" y="2626583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32363-0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BEB7326-AC1A-48ED-8E99-6BAEFCA82895}"/>
              </a:ext>
            </a:extLst>
          </p:cNvPr>
          <p:cNvSpPr txBox="1"/>
          <p:nvPr/>
        </p:nvSpPr>
        <p:spPr>
          <a:xfrm>
            <a:off x="2581802" y="2668511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7B2F51A-D92F-441D-B4FC-A0DE677822C2}"/>
              </a:ext>
            </a:extLst>
          </p:cNvPr>
          <p:cNvSpPr txBox="1"/>
          <p:nvPr/>
        </p:nvSpPr>
        <p:spPr>
          <a:xfrm>
            <a:off x="211874" y="234175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FACB02A0-65B2-4995-A05D-E107BDA0DAF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35382" y="5850538"/>
            <a:ext cx="3130288" cy="232714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A31A4282-BDBC-4029-ACDA-249C8BC124E1}"/>
              </a:ext>
            </a:extLst>
          </p:cNvPr>
          <p:cNvSpPr txBox="1"/>
          <p:nvPr/>
        </p:nvSpPr>
        <p:spPr>
          <a:xfrm>
            <a:off x="3356517" y="538604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</p:spTree>
    <p:extLst>
      <p:ext uri="{BB962C8B-B14F-4D97-AF65-F5344CB8AC3E}">
        <p14:creationId xmlns:p14="http://schemas.microsoft.com/office/powerpoint/2010/main" val="1064016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8195" t="61517" r="62916" b="30593"/>
          <a:stretch/>
        </p:blipFill>
        <p:spPr>
          <a:xfrm flipH="1">
            <a:off x="2644066" y="1550958"/>
            <a:ext cx="2841232" cy="77298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726007" y="1140445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2" name="Isosceles Triangle 11"/>
          <p:cNvSpPr/>
          <p:nvPr/>
        </p:nvSpPr>
        <p:spPr>
          <a:xfrm>
            <a:off x="5179518" y="1151596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599733" y="1104982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125145" y="81304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726006" y="869696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26572" y="509951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8735-0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726006" y="551879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7533" y="5787548"/>
            <a:ext cx="2938318" cy="232323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01083" y="17842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11873" y="545294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9A02238A-1315-4628-9D0A-5B67C3C77E8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556" t="14810" r="65833" b="74526"/>
          <a:stretch/>
        </p:blipFill>
        <p:spPr>
          <a:xfrm>
            <a:off x="2640126" y="3497512"/>
            <a:ext cx="2778144" cy="103662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A320A6B-CCB7-4A5A-8734-145344A49FCD}"/>
              </a:ext>
            </a:extLst>
          </p:cNvPr>
          <p:cNvSpPr txBox="1"/>
          <p:nvPr/>
        </p:nvSpPr>
        <p:spPr>
          <a:xfrm>
            <a:off x="2671012" y="3190170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90FE1A61-874C-40BB-BA5B-EA0846649BAC}"/>
              </a:ext>
            </a:extLst>
          </p:cNvPr>
          <p:cNvSpPr/>
          <p:nvPr/>
        </p:nvSpPr>
        <p:spPr>
          <a:xfrm>
            <a:off x="5124523" y="3201321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3796871-A8D4-4CD0-9037-C42B2CD35229}"/>
              </a:ext>
            </a:extLst>
          </p:cNvPr>
          <p:cNvSpPr txBox="1"/>
          <p:nvPr/>
        </p:nvSpPr>
        <p:spPr>
          <a:xfrm>
            <a:off x="1544738" y="3154707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4BAAF03-C581-4943-BCE2-AE914C4F2705}"/>
              </a:ext>
            </a:extLst>
          </p:cNvPr>
          <p:cNvSpPr txBox="1"/>
          <p:nvPr/>
        </p:nvSpPr>
        <p:spPr>
          <a:xfrm>
            <a:off x="2070150" y="2862767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218999A-7692-4CD6-B373-FE5137B876BE}"/>
              </a:ext>
            </a:extLst>
          </p:cNvPr>
          <p:cNvSpPr txBox="1"/>
          <p:nvPr/>
        </p:nvSpPr>
        <p:spPr>
          <a:xfrm>
            <a:off x="2671011" y="2919421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138854E-4684-4D17-A97D-4AF9A37DFBFA}"/>
              </a:ext>
            </a:extLst>
          </p:cNvPr>
          <p:cNvSpPr txBox="1"/>
          <p:nvPr/>
        </p:nvSpPr>
        <p:spPr>
          <a:xfrm>
            <a:off x="771577" y="2559676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8865-0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F5BBAA5-D6BF-41F7-ABC5-2FC33F9CB656}"/>
              </a:ext>
            </a:extLst>
          </p:cNvPr>
          <p:cNvSpPr txBox="1"/>
          <p:nvPr/>
        </p:nvSpPr>
        <p:spPr>
          <a:xfrm>
            <a:off x="2671011" y="2601604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9E8577B-1B0B-4372-BECA-8CC00677B54B}"/>
              </a:ext>
            </a:extLst>
          </p:cNvPr>
          <p:cNvSpPr txBox="1"/>
          <p:nvPr/>
        </p:nvSpPr>
        <p:spPr>
          <a:xfrm>
            <a:off x="356839" y="228600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83E81EE4-ECFA-4654-A258-C73D9D5495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6073" y="5805801"/>
            <a:ext cx="3089354" cy="228998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A28C234F-4C55-4483-B38E-7080931C5546}"/>
              </a:ext>
            </a:extLst>
          </p:cNvPr>
          <p:cNvSpPr txBox="1"/>
          <p:nvPr/>
        </p:nvSpPr>
        <p:spPr>
          <a:xfrm>
            <a:off x="3624146" y="555330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</a:p>
        </p:txBody>
      </p:sp>
    </p:spTree>
    <p:extLst>
      <p:ext uri="{BB962C8B-B14F-4D97-AF65-F5344CB8AC3E}">
        <p14:creationId xmlns:p14="http://schemas.microsoft.com/office/powerpoint/2010/main" val="33280362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5556" t="60237" r="65833" b="28886"/>
          <a:stretch/>
        </p:blipFill>
        <p:spPr>
          <a:xfrm>
            <a:off x="2752315" y="1289735"/>
            <a:ext cx="2808659" cy="106896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808642" y="1035414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2" name="Isosceles Triangle 11"/>
          <p:cNvSpPr/>
          <p:nvPr/>
        </p:nvSpPr>
        <p:spPr>
          <a:xfrm>
            <a:off x="5262153" y="1046565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682368" y="999951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07780" y="708011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808641" y="764665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909207" y="404920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9037-0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808641" y="446848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2249" y="6329909"/>
            <a:ext cx="2886263" cy="2139442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56478" y="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Q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22668" y="612202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030B3B5C-0260-45FC-873F-7834DD225B5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528" t="12037" r="64444" b="76660"/>
          <a:stretch/>
        </p:blipFill>
        <p:spPr>
          <a:xfrm flipH="1">
            <a:off x="2704279" y="3544986"/>
            <a:ext cx="2826725" cy="1093548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D9AC150-64FD-465D-BC40-6B74186337C9}"/>
              </a:ext>
            </a:extLst>
          </p:cNvPr>
          <p:cNvSpPr txBox="1"/>
          <p:nvPr/>
        </p:nvSpPr>
        <p:spPr>
          <a:xfrm>
            <a:off x="2771373" y="3301682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5990EE15-96D4-4860-B3EE-C1FF154D3DC5}"/>
              </a:ext>
            </a:extLst>
          </p:cNvPr>
          <p:cNvSpPr/>
          <p:nvPr/>
        </p:nvSpPr>
        <p:spPr>
          <a:xfrm>
            <a:off x="5224884" y="3312833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8D8E952-4DEC-4273-AF23-619B3D31E8FE}"/>
              </a:ext>
            </a:extLst>
          </p:cNvPr>
          <p:cNvSpPr txBox="1"/>
          <p:nvPr/>
        </p:nvSpPr>
        <p:spPr>
          <a:xfrm>
            <a:off x="1645099" y="3266219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18744D4-C246-4800-9587-1AFCF82D4198}"/>
              </a:ext>
            </a:extLst>
          </p:cNvPr>
          <p:cNvSpPr txBox="1"/>
          <p:nvPr/>
        </p:nvSpPr>
        <p:spPr>
          <a:xfrm>
            <a:off x="2170511" y="2974279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81EF319-C222-4321-9E05-EDFBB8DC6C08}"/>
              </a:ext>
            </a:extLst>
          </p:cNvPr>
          <p:cNvSpPr txBox="1"/>
          <p:nvPr/>
        </p:nvSpPr>
        <p:spPr>
          <a:xfrm>
            <a:off x="2771372" y="3030933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51E78D0-9B60-408B-86EF-3C726C4FF79F}"/>
              </a:ext>
            </a:extLst>
          </p:cNvPr>
          <p:cNvSpPr txBox="1"/>
          <p:nvPr/>
        </p:nvSpPr>
        <p:spPr>
          <a:xfrm>
            <a:off x="871938" y="2671188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0928-0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4ABBE64-3018-4957-8B81-D05D5AECD150}"/>
              </a:ext>
            </a:extLst>
          </p:cNvPr>
          <p:cNvSpPr txBox="1"/>
          <p:nvPr/>
        </p:nvSpPr>
        <p:spPr>
          <a:xfrm>
            <a:off x="2771372" y="2713116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2FD044E-1530-4910-BE6E-F33C7FFC3DE7}"/>
              </a:ext>
            </a:extLst>
          </p:cNvPr>
          <p:cNvSpPr txBox="1"/>
          <p:nvPr/>
        </p:nvSpPr>
        <p:spPr>
          <a:xfrm>
            <a:off x="312235" y="235290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D111D6DC-CEC0-4B05-85AC-0D78639271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79061" y="6309114"/>
            <a:ext cx="2942958" cy="2191564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2B89CE9-C7EB-4A27-A201-88283B275326}"/>
              </a:ext>
            </a:extLst>
          </p:cNvPr>
          <p:cNvSpPr txBox="1"/>
          <p:nvPr/>
        </p:nvSpPr>
        <p:spPr>
          <a:xfrm>
            <a:off x="2877014" y="617777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</a:p>
        </p:txBody>
      </p:sp>
    </p:spTree>
    <p:extLst>
      <p:ext uri="{BB962C8B-B14F-4D97-AF65-F5344CB8AC3E}">
        <p14:creationId xmlns:p14="http://schemas.microsoft.com/office/powerpoint/2010/main" val="37385564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6528" t="59384" r="64444" b="30379"/>
          <a:stretch/>
        </p:blipFill>
        <p:spPr>
          <a:xfrm flipH="1">
            <a:off x="2601426" y="1412393"/>
            <a:ext cx="2873822" cy="1006883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715617" y="1123501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12" name="Isosceles Triangle 11"/>
          <p:cNvSpPr/>
          <p:nvPr/>
        </p:nvSpPr>
        <p:spPr>
          <a:xfrm>
            <a:off x="5169128" y="1134652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/>
          <p:cNvSpPr txBox="1"/>
          <p:nvPr/>
        </p:nvSpPr>
        <p:spPr>
          <a:xfrm>
            <a:off x="1589343" y="1088038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114755" y="796098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715616" y="852752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71937" y="493007"/>
            <a:ext cx="1938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LS002251300-02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715616" y="534935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592" y="6141845"/>
            <a:ext cx="3165262" cy="2349187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356837" y="111512"/>
            <a:ext cx="3402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89569" y="5765183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A96DDA23-3A3B-4845-A41D-F415349A97C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5610" t="13046" r="64878" b="76717"/>
          <a:stretch/>
        </p:blipFill>
        <p:spPr>
          <a:xfrm>
            <a:off x="2664052" y="3766704"/>
            <a:ext cx="2933860" cy="1002401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7EC9E500-DD95-421D-8D1D-E0C88157DCF9}"/>
              </a:ext>
            </a:extLst>
          </p:cNvPr>
          <p:cNvSpPr txBox="1"/>
          <p:nvPr/>
        </p:nvSpPr>
        <p:spPr>
          <a:xfrm>
            <a:off x="2804769" y="3481895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ED182237-61BB-406C-ADF8-8284F2A02C8C}"/>
              </a:ext>
            </a:extLst>
          </p:cNvPr>
          <p:cNvSpPr/>
          <p:nvPr/>
        </p:nvSpPr>
        <p:spPr>
          <a:xfrm>
            <a:off x="5258280" y="3493046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8D7163D-366E-4FB5-A22E-49143F1D6950}"/>
              </a:ext>
            </a:extLst>
          </p:cNvPr>
          <p:cNvSpPr txBox="1"/>
          <p:nvPr/>
        </p:nvSpPr>
        <p:spPr>
          <a:xfrm>
            <a:off x="1678495" y="3446432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6E5EEC7-65D6-482B-A291-0EED56878D85}"/>
              </a:ext>
            </a:extLst>
          </p:cNvPr>
          <p:cNvSpPr txBox="1"/>
          <p:nvPr/>
        </p:nvSpPr>
        <p:spPr>
          <a:xfrm>
            <a:off x="2203907" y="3154492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B621BC8-4D0E-4588-99B7-32FECD9C0628}"/>
              </a:ext>
            </a:extLst>
          </p:cNvPr>
          <p:cNvSpPr txBox="1"/>
          <p:nvPr/>
        </p:nvSpPr>
        <p:spPr>
          <a:xfrm>
            <a:off x="2804768" y="3211146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3EA1938-1381-41EE-9576-36D1FB7946CD}"/>
              </a:ext>
            </a:extLst>
          </p:cNvPr>
          <p:cNvSpPr txBox="1"/>
          <p:nvPr/>
        </p:nvSpPr>
        <p:spPr>
          <a:xfrm>
            <a:off x="905334" y="2851401"/>
            <a:ext cx="199445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23016-0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4D08E08-9624-41C6-AE0A-ED9156DF84C5}"/>
              </a:ext>
            </a:extLst>
          </p:cNvPr>
          <p:cNvSpPr txBox="1"/>
          <p:nvPr/>
        </p:nvSpPr>
        <p:spPr>
          <a:xfrm>
            <a:off x="2804768" y="2893329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B07A79A-26AE-40AF-8C99-5533C6C31AEE}"/>
              </a:ext>
            </a:extLst>
          </p:cNvPr>
          <p:cNvSpPr txBox="1"/>
          <p:nvPr/>
        </p:nvSpPr>
        <p:spPr>
          <a:xfrm>
            <a:off x="490654" y="264284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V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F3D811D6-4435-4178-B902-AA68719CAA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09362" y="6280900"/>
            <a:ext cx="2962089" cy="2195648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3A397FA2-80A1-4B12-B113-FF161D51A0EB}"/>
              </a:ext>
            </a:extLst>
          </p:cNvPr>
          <p:cNvSpPr txBox="1"/>
          <p:nvPr/>
        </p:nvSpPr>
        <p:spPr>
          <a:xfrm>
            <a:off x="3389972" y="586554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</p:spTree>
    <p:extLst>
      <p:ext uri="{BB962C8B-B14F-4D97-AF65-F5344CB8AC3E}">
        <p14:creationId xmlns:p14="http://schemas.microsoft.com/office/powerpoint/2010/main" val="1865567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5772" t="62484" r="65366" b="27278"/>
          <a:stretch/>
        </p:blipFill>
        <p:spPr>
          <a:xfrm>
            <a:off x="2864773" y="1448806"/>
            <a:ext cx="2841891" cy="100446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2943922" y="1074790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5" name="Isosceles Triangle 4"/>
          <p:cNvSpPr/>
          <p:nvPr/>
        </p:nvSpPr>
        <p:spPr>
          <a:xfrm>
            <a:off x="5397433" y="1085941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/>
          <p:cNvSpPr txBox="1"/>
          <p:nvPr/>
        </p:nvSpPr>
        <p:spPr>
          <a:xfrm>
            <a:off x="1817648" y="1039327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343060" y="747387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943921" y="804041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44487" y="444296"/>
            <a:ext cx="19831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CGC00113056-02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943921" y="486224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4582" y="6124784"/>
            <a:ext cx="2962089" cy="2195648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289931" y="8921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Y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4537" y="5776331"/>
            <a:ext cx="6021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A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852597" y="8774668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4 Fig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49AC9F33-4515-4565-AA2F-C64177256ED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886" t="29775" r="14441" b="38514"/>
          <a:stretch/>
        </p:blipFill>
        <p:spPr>
          <a:xfrm flipH="1">
            <a:off x="2967880" y="3675482"/>
            <a:ext cx="2718677" cy="829610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5A316E6A-EE43-4924-9C4A-26C9B0C74C4E}"/>
              </a:ext>
            </a:extLst>
          </p:cNvPr>
          <p:cNvSpPr txBox="1"/>
          <p:nvPr/>
        </p:nvSpPr>
        <p:spPr>
          <a:xfrm>
            <a:off x="2967882" y="3336928"/>
            <a:ext cx="25875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0  1  2  4 8 16 1  2  4 8 16</a:t>
            </a:r>
          </a:p>
        </p:txBody>
      </p:sp>
      <p:sp>
        <p:nvSpPr>
          <p:cNvPr id="27" name="Isosceles Triangle 26">
            <a:extLst>
              <a:ext uri="{FF2B5EF4-FFF2-40B4-BE49-F238E27FC236}">
                <a16:creationId xmlns:a16="http://schemas.microsoft.com/office/drawing/2014/main" id="{05DA1FE6-A61E-4048-8EFE-714E57F55591}"/>
              </a:ext>
            </a:extLst>
          </p:cNvPr>
          <p:cNvSpPr/>
          <p:nvPr/>
        </p:nvSpPr>
        <p:spPr>
          <a:xfrm>
            <a:off x="5421393" y="3348079"/>
            <a:ext cx="200722" cy="256478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F8CDA40-1DD6-4574-863B-18F25D8461BD}"/>
              </a:ext>
            </a:extLst>
          </p:cNvPr>
          <p:cNvSpPr txBox="1"/>
          <p:nvPr/>
        </p:nvSpPr>
        <p:spPr>
          <a:xfrm>
            <a:off x="1841608" y="3301465"/>
            <a:ext cx="12212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E971797-3F99-4C92-98BC-ABB20D76B53D}"/>
              </a:ext>
            </a:extLst>
          </p:cNvPr>
          <p:cNvSpPr txBox="1"/>
          <p:nvPr/>
        </p:nvSpPr>
        <p:spPr>
          <a:xfrm>
            <a:off x="2367020" y="3009525"/>
            <a:ext cx="6735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WR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F50B7D8-8DC8-4A9F-BE36-2CE109FA8759}"/>
              </a:ext>
            </a:extLst>
          </p:cNvPr>
          <p:cNvSpPr txBox="1"/>
          <p:nvPr/>
        </p:nvSpPr>
        <p:spPr>
          <a:xfrm>
            <a:off x="2967881" y="3066179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+ + + + 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C0AC118-2CD7-4414-816E-4D07C61BE166}"/>
              </a:ext>
            </a:extLst>
          </p:cNvPr>
          <p:cNvSpPr txBox="1"/>
          <p:nvPr/>
        </p:nvSpPr>
        <p:spPr>
          <a:xfrm>
            <a:off x="1124202" y="2706434"/>
            <a:ext cx="19270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MLS001139594-0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5DECEB7-796E-4587-8EEA-35218537EDAD}"/>
              </a:ext>
            </a:extLst>
          </p:cNvPr>
          <p:cNvSpPr txBox="1"/>
          <p:nvPr/>
        </p:nvSpPr>
        <p:spPr>
          <a:xfrm>
            <a:off x="2967881" y="2748362"/>
            <a:ext cx="24400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ourier New" panose="02070309020205020404" pitchFamily="49" charset="0"/>
                <a:cs typeface="Courier New" panose="02070309020205020404" pitchFamily="49" charset="0"/>
              </a:rPr>
              <a:t>- + + + + + - - - - 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F3A4C2C-52DA-4420-9BDA-539E43778A7A}"/>
              </a:ext>
            </a:extLst>
          </p:cNvPr>
          <p:cNvSpPr txBox="1"/>
          <p:nvPr/>
        </p:nvSpPr>
        <p:spPr>
          <a:xfrm>
            <a:off x="367989" y="236405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</a:p>
        </p:txBody>
      </p:sp>
      <p:pic>
        <p:nvPicPr>
          <p:cNvPr id="34" name="Picture 33">
            <a:extLst>
              <a:ext uri="{FF2B5EF4-FFF2-40B4-BE49-F238E27FC236}">
                <a16:creationId xmlns:a16="http://schemas.microsoft.com/office/drawing/2014/main" id="{17293BBB-91BA-4965-B5CE-1A024035D8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21715" y="6120896"/>
            <a:ext cx="2945992" cy="2183716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49670A99-E249-4A3B-9698-2DC3874ECDD9}"/>
              </a:ext>
            </a:extLst>
          </p:cNvPr>
          <p:cNvSpPr txBox="1"/>
          <p:nvPr/>
        </p:nvSpPr>
        <p:spPr>
          <a:xfrm>
            <a:off x="3278459" y="5798634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B</a:t>
            </a:r>
          </a:p>
        </p:txBody>
      </p:sp>
    </p:spTree>
    <p:extLst>
      <p:ext uri="{BB962C8B-B14F-4D97-AF65-F5344CB8AC3E}">
        <p14:creationId xmlns:p14="http://schemas.microsoft.com/office/powerpoint/2010/main" val="10957349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8</TotalTime>
  <Words>588</Words>
  <Application>Microsoft Office PowerPoint</Application>
  <PresentationFormat>Letter Paper (8.5x11 in)</PresentationFormat>
  <Paragraphs>11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Courier New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mmers, Joshua (NIH/NIA/IRP) [E]</dc:creator>
  <cp:lastModifiedBy>Sommers, Joshua (NIH/NIA/IRP) [E]</cp:lastModifiedBy>
  <cp:revision>30</cp:revision>
  <dcterms:created xsi:type="dcterms:W3CDTF">2017-04-20T16:52:01Z</dcterms:created>
  <dcterms:modified xsi:type="dcterms:W3CDTF">2018-12-20T22:44:39Z</dcterms:modified>
</cp:coreProperties>
</file>